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2" r:id="rId2"/>
    <p:sldId id="281" r:id="rId3"/>
    <p:sldId id="259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 Belén Martín Diana" initials="ABMD" lastIdx="1" clrIdx="0">
    <p:extLst>
      <p:ext uri="{19B8F6BF-5375-455C-9EA6-DF929625EA0E}">
        <p15:presenceInfo xmlns:p15="http://schemas.microsoft.com/office/powerpoint/2012/main" userId="S-1-5-21-217838727-779646833-3878702524-25580" providerId="AD"/>
      </p:ext>
    </p:extLst>
  </p:cmAuthor>
  <p:cmAuthor id="2" name="Daniel Rico" initials="DR" lastIdx="1" clrIdx="1">
    <p:extLst>
      <p:ext uri="{19B8F6BF-5375-455C-9EA6-DF929625EA0E}">
        <p15:presenceInfo xmlns:p15="http://schemas.microsoft.com/office/powerpoint/2012/main" userId="0a475d9e3b43bc6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E536C6F-B2BD-4ADC-B46C-67AB3FA8FEBD}" v="201" dt="2020-04-12T17:04:10.84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Estilo medio 2 - Énfasis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Estilo medio 3 - Énfasis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FECB4D8-DB02-4DC6-A0A2-4F2EBAE1DC90}" styleName="Estilo medio 1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Estilo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80" autoAdjust="0"/>
    <p:restoredTop sz="91781" autoAdjust="0"/>
  </p:normalViewPr>
  <p:slideViewPr>
    <p:cSldViewPr snapToGrid="0">
      <p:cViewPr>
        <p:scale>
          <a:sx n="66" d="100"/>
          <a:sy n="66" d="100"/>
        </p:scale>
        <p:origin x="38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4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octorado\Salvado%20ITACyL\Ensayos\NOEM&#205;%20ALONSO%20Resumen%20ensayos\Feli\Reolog&#237;a%20geles\figura%20m&#243;dulos-frecuencias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'Julio+48y49Nov'!$Q$79</c:f>
              <c:strCache>
                <c:ptCount val="1"/>
                <c:pt idx="0">
                  <c:v>G´ CONTROL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885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88500"/>
                </a:schemeClr>
              </a:solidFill>
              <a:ln w="6350" cap="flat" cmpd="sng" algn="ctr">
                <a:solidFill>
                  <a:schemeClr val="dk1">
                    <a:tint val="885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Q$80:$Q$101</c:f>
              <c:numCache>
                <c:formatCode>General</c:formatCode>
                <c:ptCount val="22"/>
                <c:pt idx="0">
                  <c:v>1234.5</c:v>
                </c:pt>
                <c:pt idx="1">
                  <c:v>1208.5</c:v>
                </c:pt>
                <c:pt idx="2">
                  <c:v>1184.5</c:v>
                </c:pt>
                <c:pt idx="3">
                  <c:v>1166</c:v>
                </c:pt>
                <c:pt idx="4">
                  <c:v>1145.5</c:v>
                </c:pt>
                <c:pt idx="5">
                  <c:v>1126.5</c:v>
                </c:pt>
                <c:pt idx="6">
                  <c:v>1107.5</c:v>
                </c:pt>
                <c:pt idx="7">
                  <c:v>1088</c:v>
                </c:pt>
                <c:pt idx="8">
                  <c:v>1071.5</c:v>
                </c:pt>
                <c:pt idx="9">
                  <c:v>1054.3499999999999</c:v>
                </c:pt>
                <c:pt idx="10">
                  <c:v>1037.5999999999999</c:v>
                </c:pt>
                <c:pt idx="11">
                  <c:v>1022</c:v>
                </c:pt>
                <c:pt idx="12">
                  <c:v>1006.8</c:v>
                </c:pt>
                <c:pt idx="13">
                  <c:v>991.94999999999959</c:v>
                </c:pt>
                <c:pt idx="14">
                  <c:v>955.34999999999957</c:v>
                </c:pt>
                <c:pt idx="15">
                  <c:v>940</c:v>
                </c:pt>
                <c:pt idx="16">
                  <c:v>927.3</c:v>
                </c:pt>
                <c:pt idx="17">
                  <c:v>912.40000000000009</c:v>
                </c:pt>
                <c:pt idx="18">
                  <c:v>905.65</c:v>
                </c:pt>
                <c:pt idx="19">
                  <c:v>907.9</c:v>
                </c:pt>
                <c:pt idx="20">
                  <c:v>896.75</c:v>
                </c:pt>
                <c:pt idx="21">
                  <c:v>885.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731-4EE4-B589-A9557F29114F}"/>
            </c:ext>
          </c:extLst>
        </c:ser>
        <c:ser>
          <c:idx val="1"/>
          <c:order val="1"/>
          <c:tx>
            <c:strRef>
              <c:f>'Julio+48y49Nov'!$R$79</c:f>
              <c:strCache>
                <c:ptCount val="1"/>
                <c:pt idx="0">
                  <c:v>G´ AUT-130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550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55000"/>
                </a:schemeClr>
              </a:solidFill>
              <a:ln w="6350" cap="flat" cmpd="sng" algn="ctr">
                <a:solidFill>
                  <a:schemeClr val="dk1">
                    <a:tint val="550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R$80:$R$101</c:f>
              <c:numCache>
                <c:formatCode>General</c:formatCode>
                <c:ptCount val="22"/>
                <c:pt idx="0">
                  <c:v>1062.5</c:v>
                </c:pt>
                <c:pt idx="1">
                  <c:v>1034.5</c:v>
                </c:pt>
                <c:pt idx="2">
                  <c:v>1011.5</c:v>
                </c:pt>
                <c:pt idx="3">
                  <c:v>993.34999999999945</c:v>
                </c:pt>
                <c:pt idx="4">
                  <c:v>975.9</c:v>
                </c:pt>
                <c:pt idx="5">
                  <c:v>958.84999999999957</c:v>
                </c:pt>
                <c:pt idx="6">
                  <c:v>940.59999999999991</c:v>
                </c:pt>
                <c:pt idx="7">
                  <c:v>922.55</c:v>
                </c:pt>
                <c:pt idx="8">
                  <c:v>907.3</c:v>
                </c:pt>
                <c:pt idx="9">
                  <c:v>891.44999999999959</c:v>
                </c:pt>
                <c:pt idx="10">
                  <c:v>876.05</c:v>
                </c:pt>
                <c:pt idx="11">
                  <c:v>861.7</c:v>
                </c:pt>
                <c:pt idx="12">
                  <c:v>847.84999999999945</c:v>
                </c:pt>
                <c:pt idx="13">
                  <c:v>833.55</c:v>
                </c:pt>
                <c:pt idx="14">
                  <c:v>819.8</c:v>
                </c:pt>
                <c:pt idx="15">
                  <c:v>807.25</c:v>
                </c:pt>
                <c:pt idx="16">
                  <c:v>796.25</c:v>
                </c:pt>
                <c:pt idx="17">
                  <c:v>783.75</c:v>
                </c:pt>
                <c:pt idx="18">
                  <c:v>771.34999999999957</c:v>
                </c:pt>
                <c:pt idx="19">
                  <c:v>761.5</c:v>
                </c:pt>
                <c:pt idx="20">
                  <c:v>749.94999999999959</c:v>
                </c:pt>
                <c:pt idx="21">
                  <c:v>740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731-4EE4-B589-A9557F29114F}"/>
            </c:ext>
          </c:extLst>
        </c:ser>
        <c:ser>
          <c:idx val="2"/>
          <c:order val="2"/>
          <c:tx>
            <c:strRef>
              <c:f>'Julio+48y49Nov'!$S$79</c:f>
              <c:strCache>
                <c:ptCount val="1"/>
                <c:pt idx="0">
                  <c:v>G´ AUT-115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75000"/>
                </a:schemeClr>
              </a:solidFill>
              <a:prstDash val="solid"/>
              <a:round/>
            </a:ln>
            <a:effectLst/>
          </c:spPr>
          <c:marker>
            <c:spPr>
              <a:solidFill>
                <a:schemeClr val="dk1">
                  <a:tint val="75000"/>
                </a:schemeClr>
              </a:solidFill>
              <a:ln w="6350" cap="flat" cmpd="sng" algn="ctr">
                <a:solidFill>
                  <a:schemeClr val="dk1">
                    <a:tint val="750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S$80:$S$101</c:f>
              <c:numCache>
                <c:formatCode>General</c:formatCode>
                <c:ptCount val="22"/>
                <c:pt idx="0">
                  <c:v>1123.5</c:v>
                </c:pt>
                <c:pt idx="1">
                  <c:v>1093.5</c:v>
                </c:pt>
                <c:pt idx="2">
                  <c:v>1069.45</c:v>
                </c:pt>
                <c:pt idx="3">
                  <c:v>1051.9000000000001</c:v>
                </c:pt>
                <c:pt idx="4">
                  <c:v>1033.4000000000001</c:v>
                </c:pt>
                <c:pt idx="5">
                  <c:v>1016.15</c:v>
                </c:pt>
                <c:pt idx="6">
                  <c:v>996.8</c:v>
                </c:pt>
                <c:pt idx="7">
                  <c:v>977.1</c:v>
                </c:pt>
                <c:pt idx="8">
                  <c:v>962.2</c:v>
                </c:pt>
                <c:pt idx="9">
                  <c:v>944.9</c:v>
                </c:pt>
                <c:pt idx="10">
                  <c:v>926.8</c:v>
                </c:pt>
                <c:pt idx="11">
                  <c:v>913.94999999999959</c:v>
                </c:pt>
                <c:pt idx="12">
                  <c:v>900.44999999999959</c:v>
                </c:pt>
                <c:pt idx="13">
                  <c:v>885.84999999999957</c:v>
                </c:pt>
                <c:pt idx="14">
                  <c:v>870.25</c:v>
                </c:pt>
                <c:pt idx="15">
                  <c:v>855.34999999999957</c:v>
                </c:pt>
                <c:pt idx="16">
                  <c:v>841.5</c:v>
                </c:pt>
                <c:pt idx="17">
                  <c:v>827.4</c:v>
                </c:pt>
                <c:pt idx="18">
                  <c:v>816.9</c:v>
                </c:pt>
                <c:pt idx="19">
                  <c:v>806.09999999999991</c:v>
                </c:pt>
                <c:pt idx="20">
                  <c:v>794.1</c:v>
                </c:pt>
                <c:pt idx="21">
                  <c:v>782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731-4EE4-B589-A9557F29114F}"/>
            </c:ext>
          </c:extLst>
        </c:ser>
        <c:ser>
          <c:idx val="3"/>
          <c:order val="3"/>
          <c:tx>
            <c:strRef>
              <c:f>'Julio+48y49Nov'!$T$79</c:f>
              <c:strCache>
                <c:ptCount val="1"/>
                <c:pt idx="0">
                  <c:v>G´ AUT-100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985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dk1">
                  <a:tint val="98500"/>
                </a:schemeClr>
              </a:solidFill>
              <a:ln w="6350" cap="flat" cmpd="sng" algn="ctr">
                <a:solidFill>
                  <a:schemeClr val="dk1">
                    <a:tint val="985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T$80:$T$101</c:f>
              <c:numCache>
                <c:formatCode>General</c:formatCode>
                <c:ptCount val="22"/>
                <c:pt idx="0">
                  <c:v>778.55</c:v>
                </c:pt>
                <c:pt idx="1">
                  <c:v>760.84999999999945</c:v>
                </c:pt>
                <c:pt idx="2">
                  <c:v>746.15</c:v>
                </c:pt>
                <c:pt idx="3">
                  <c:v>734.1</c:v>
                </c:pt>
                <c:pt idx="4">
                  <c:v>721.55</c:v>
                </c:pt>
                <c:pt idx="5">
                  <c:v>708.9</c:v>
                </c:pt>
                <c:pt idx="6">
                  <c:v>695.34999999999957</c:v>
                </c:pt>
                <c:pt idx="7">
                  <c:v>683.05</c:v>
                </c:pt>
                <c:pt idx="8">
                  <c:v>671.75</c:v>
                </c:pt>
                <c:pt idx="9">
                  <c:v>659.9</c:v>
                </c:pt>
                <c:pt idx="10">
                  <c:v>648.5499999999995</c:v>
                </c:pt>
                <c:pt idx="11">
                  <c:v>637.75</c:v>
                </c:pt>
                <c:pt idx="12">
                  <c:v>626.6</c:v>
                </c:pt>
                <c:pt idx="13">
                  <c:v>616.29999999999995</c:v>
                </c:pt>
                <c:pt idx="14">
                  <c:v>606.84999999999945</c:v>
                </c:pt>
                <c:pt idx="15">
                  <c:v>597.20000000000005</c:v>
                </c:pt>
                <c:pt idx="16">
                  <c:v>588.34999999999957</c:v>
                </c:pt>
                <c:pt idx="17">
                  <c:v>578.65</c:v>
                </c:pt>
                <c:pt idx="18">
                  <c:v>569.75</c:v>
                </c:pt>
                <c:pt idx="19">
                  <c:v>561.94999999999959</c:v>
                </c:pt>
                <c:pt idx="20">
                  <c:v>553.84999999999945</c:v>
                </c:pt>
                <c:pt idx="21">
                  <c:v>545.849999999999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731-4EE4-B589-A9557F29114F}"/>
            </c:ext>
          </c:extLst>
        </c:ser>
        <c:ser>
          <c:idx val="4"/>
          <c:order val="4"/>
          <c:tx>
            <c:strRef>
              <c:f>'Julio+48y49Nov'!$U$79</c:f>
              <c:strCache>
                <c:ptCount val="1"/>
                <c:pt idx="0">
                  <c:v>G´´ CONTROL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30000"/>
                </a:schemeClr>
              </a:solidFill>
              <a:prstDash val="solid"/>
              <a:round/>
            </a:ln>
            <a:effectLst/>
          </c:spPr>
          <c:marker>
            <c:symbol val="diamond"/>
            <c:size val="7"/>
            <c:spPr>
              <a:solidFill>
                <a:schemeClr val="dk1">
                  <a:tint val="30000"/>
                </a:schemeClr>
              </a:solidFill>
              <a:ln w="6350" cap="flat" cmpd="sng" algn="ctr">
                <a:solidFill>
                  <a:schemeClr val="dk1">
                    <a:tint val="300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U$80:$U$101</c:f>
              <c:numCache>
                <c:formatCode>General</c:formatCode>
                <c:ptCount val="22"/>
                <c:pt idx="0">
                  <c:v>344.45</c:v>
                </c:pt>
                <c:pt idx="1">
                  <c:v>333.9</c:v>
                </c:pt>
                <c:pt idx="2">
                  <c:v>321.60000000000002</c:v>
                </c:pt>
                <c:pt idx="3">
                  <c:v>309.5</c:v>
                </c:pt>
                <c:pt idx="4">
                  <c:v>299.60000000000002</c:v>
                </c:pt>
                <c:pt idx="5">
                  <c:v>290.75</c:v>
                </c:pt>
                <c:pt idx="6">
                  <c:v>282.60000000000002</c:v>
                </c:pt>
                <c:pt idx="7">
                  <c:v>273.35000000000002</c:v>
                </c:pt>
                <c:pt idx="8">
                  <c:v>265.35000000000002</c:v>
                </c:pt>
                <c:pt idx="9">
                  <c:v>256.64999999999998</c:v>
                </c:pt>
                <c:pt idx="10">
                  <c:v>248.85000000000011</c:v>
                </c:pt>
                <c:pt idx="11">
                  <c:v>242.05</c:v>
                </c:pt>
                <c:pt idx="12">
                  <c:v>234.95000000000007</c:v>
                </c:pt>
                <c:pt idx="13">
                  <c:v>228.3</c:v>
                </c:pt>
                <c:pt idx="14">
                  <c:v>220.6</c:v>
                </c:pt>
                <c:pt idx="15">
                  <c:v>211.75</c:v>
                </c:pt>
                <c:pt idx="16">
                  <c:v>205.35000000000014</c:v>
                </c:pt>
                <c:pt idx="17">
                  <c:v>198.5</c:v>
                </c:pt>
                <c:pt idx="18">
                  <c:v>195.5</c:v>
                </c:pt>
                <c:pt idx="19">
                  <c:v>192.9</c:v>
                </c:pt>
                <c:pt idx="20">
                  <c:v>187.2</c:v>
                </c:pt>
                <c:pt idx="21">
                  <c:v>1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731-4EE4-B589-A9557F29114F}"/>
            </c:ext>
          </c:extLst>
        </c:ser>
        <c:ser>
          <c:idx val="5"/>
          <c:order val="5"/>
          <c:tx>
            <c:strRef>
              <c:f>'Julio+48y49Nov'!$V$79</c:f>
              <c:strCache>
                <c:ptCount val="1"/>
                <c:pt idx="0">
                  <c:v>G´´ AUT-130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60000"/>
                </a:schemeClr>
              </a:solidFill>
              <a:prstDash val="solid"/>
              <a:round/>
            </a:ln>
            <a:effectLst/>
          </c:spPr>
          <c:marker>
            <c:symbol val="square"/>
            <c:size val="7"/>
            <c:spPr>
              <a:solidFill>
                <a:schemeClr val="dk1">
                  <a:tint val="60000"/>
                </a:schemeClr>
              </a:solidFill>
              <a:ln w="6350" cap="flat" cmpd="sng" algn="ctr">
                <a:solidFill>
                  <a:schemeClr val="dk1">
                    <a:tint val="600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V$80:$V$101</c:f>
              <c:numCache>
                <c:formatCode>General</c:formatCode>
                <c:ptCount val="22"/>
                <c:pt idx="0">
                  <c:v>325.60000000000002</c:v>
                </c:pt>
                <c:pt idx="1">
                  <c:v>311.5</c:v>
                </c:pt>
                <c:pt idx="2">
                  <c:v>300.8</c:v>
                </c:pt>
                <c:pt idx="3">
                  <c:v>288.60000000000002</c:v>
                </c:pt>
                <c:pt idx="4">
                  <c:v>278.95</c:v>
                </c:pt>
                <c:pt idx="5">
                  <c:v>270.25</c:v>
                </c:pt>
                <c:pt idx="6">
                  <c:v>262.10000000000002</c:v>
                </c:pt>
                <c:pt idx="7">
                  <c:v>254.10000000000002</c:v>
                </c:pt>
                <c:pt idx="8">
                  <c:v>245</c:v>
                </c:pt>
                <c:pt idx="9">
                  <c:v>237</c:v>
                </c:pt>
                <c:pt idx="10">
                  <c:v>229.8</c:v>
                </c:pt>
                <c:pt idx="11">
                  <c:v>222.85000000000014</c:v>
                </c:pt>
                <c:pt idx="12">
                  <c:v>215.7</c:v>
                </c:pt>
                <c:pt idx="13">
                  <c:v>209.45000000000007</c:v>
                </c:pt>
                <c:pt idx="14">
                  <c:v>202.85000000000014</c:v>
                </c:pt>
                <c:pt idx="15">
                  <c:v>196.7</c:v>
                </c:pt>
                <c:pt idx="16">
                  <c:v>190.95000000000007</c:v>
                </c:pt>
                <c:pt idx="17">
                  <c:v>185.05</c:v>
                </c:pt>
                <c:pt idx="18">
                  <c:v>180.7</c:v>
                </c:pt>
                <c:pt idx="19">
                  <c:v>175.75</c:v>
                </c:pt>
                <c:pt idx="20">
                  <c:v>170.75</c:v>
                </c:pt>
                <c:pt idx="21">
                  <c:v>166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731-4EE4-B589-A9557F29114F}"/>
            </c:ext>
          </c:extLst>
        </c:ser>
        <c:ser>
          <c:idx val="6"/>
          <c:order val="6"/>
          <c:tx>
            <c:strRef>
              <c:f>'Julio+48y49Nov'!$W$79</c:f>
              <c:strCache>
                <c:ptCount val="1"/>
                <c:pt idx="0">
                  <c:v>G´´ AUT-115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80000"/>
                </a:schemeClr>
              </a:solidFill>
              <a:prstDash val="solid"/>
              <a:round/>
            </a:ln>
            <a:effectLst/>
          </c:spPr>
          <c:marker>
            <c:symbol val="triangle"/>
            <c:size val="7"/>
            <c:spPr>
              <a:solidFill>
                <a:schemeClr val="dk1">
                  <a:tint val="80000"/>
                </a:schemeClr>
              </a:solidFill>
              <a:ln w="6350" cap="flat" cmpd="sng" algn="ctr">
                <a:solidFill>
                  <a:schemeClr val="dk1">
                    <a:tint val="800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W$80:$W$101</c:f>
              <c:numCache>
                <c:formatCode>General</c:formatCode>
                <c:ptCount val="22"/>
                <c:pt idx="0">
                  <c:v>335.7</c:v>
                </c:pt>
                <c:pt idx="1">
                  <c:v>327.14999999999998</c:v>
                </c:pt>
                <c:pt idx="2">
                  <c:v>313.60000000000002</c:v>
                </c:pt>
                <c:pt idx="3">
                  <c:v>301.14999999999998</c:v>
                </c:pt>
                <c:pt idx="4">
                  <c:v>290.35000000000002</c:v>
                </c:pt>
                <c:pt idx="5">
                  <c:v>281.25</c:v>
                </c:pt>
                <c:pt idx="6">
                  <c:v>272</c:v>
                </c:pt>
                <c:pt idx="7">
                  <c:v>263.04999999999995</c:v>
                </c:pt>
                <c:pt idx="8">
                  <c:v>254.4</c:v>
                </c:pt>
                <c:pt idx="9">
                  <c:v>246.15</c:v>
                </c:pt>
                <c:pt idx="10">
                  <c:v>237.7</c:v>
                </c:pt>
                <c:pt idx="11">
                  <c:v>230.45000000000007</c:v>
                </c:pt>
                <c:pt idx="12">
                  <c:v>223.45000000000007</c:v>
                </c:pt>
                <c:pt idx="13">
                  <c:v>216.85000000000011</c:v>
                </c:pt>
                <c:pt idx="14">
                  <c:v>210.2</c:v>
                </c:pt>
                <c:pt idx="15">
                  <c:v>203.65</c:v>
                </c:pt>
                <c:pt idx="16">
                  <c:v>197</c:v>
                </c:pt>
                <c:pt idx="17">
                  <c:v>191.15</c:v>
                </c:pt>
                <c:pt idx="18">
                  <c:v>186.9</c:v>
                </c:pt>
                <c:pt idx="19">
                  <c:v>182.1</c:v>
                </c:pt>
                <c:pt idx="20">
                  <c:v>177.95000000000007</c:v>
                </c:pt>
                <c:pt idx="21">
                  <c:v>173.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E731-4EE4-B589-A9557F29114F}"/>
            </c:ext>
          </c:extLst>
        </c:ser>
        <c:ser>
          <c:idx val="7"/>
          <c:order val="7"/>
          <c:tx>
            <c:strRef>
              <c:f>'Julio+48y49Nov'!$X$79</c:f>
              <c:strCache>
                <c:ptCount val="1"/>
                <c:pt idx="0">
                  <c:v>G´´  AUT-100</c:v>
                </c:pt>
              </c:strCache>
            </c:strRef>
          </c:tx>
          <c:spPr>
            <a:ln w="19050" cap="rnd" cmpd="sng" algn="ctr">
              <a:solidFill>
                <a:schemeClr val="dk1">
                  <a:tint val="885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dk1">
                  <a:tint val="88500"/>
                </a:schemeClr>
              </a:solidFill>
              <a:ln w="6350" cap="flat" cmpd="sng" algn="ctr">
                <a:solidFill>
                  <a:schemeClr val="dk1">
                    <a:tint val="88500"/>
                  </a:schemeClr>
                </a:solidFill>
                <a:prstDash val="solid"/>
                <a:round/>
              </a:ln>
              <a:effectLst/>
            </c:spPr>
          </c:marker>
          <c:xVal>
            <c:numRef>
              <c:f>'Julio+48y49Nov'!$P$80:$P$101</c:f>
              <c:numCache>
                <c:formatCode>General</c:formatCode>
                <c:ptCount val="22"/>
                <c:pt idx="0">
                  <c:v>10</c:v>
                </c:pt>
                <c:pt idx="1">
                  <c:v>8.9620000000000068</c:v>
                </c:pt>
                <c:pt idx="2">
                  <c:v>8.0310000000000006</c:v>
                </c:pt>
                <c:pt idx="3">
                  <c:v>7.1969999999999965</c:v>
                </c:pt>
                <c:pt idx="4">
                  <c:v>6.4489999999999998</c:v>
                </c:pt>
                <c:pt idx="5">
                  <c:v>5.78</c:v>
                </c:pt>
                <c:pt idx="6">
                  <c:v>5.1790000000000003</c:v>
                </c:pt>
                <c:pt idx="7">
                  <c:v>4.6419999999999995</c:v>
                </c:pt>
                <c:pt idx="8">
                  <c:v>4.1599999999999975</c:v>
                </c:pt>
                <c:pt idx="9">
                  <c:v>3.7280000000000002</c:v>
                </c:pt>
                <c:pt idx="10">
                  <c:v>3.34</c:v>
                </c:pt>
                <c:pt idx="11">
                  <c:v>2.9939999999999998</c:v>
                </c:pt>
                <c:pt idx="12">
                  <c:v>2.6829999999999998</c:v>
                </c:pt>
                <c:pt idx="13">
                  <c:v>2.4039999999999999</c:v>
                </c:pt>
                <c:pt idx="14">
                  <c:v>2.1539999999999999</c:v>
                </c:pt>
                <c:pt idx="15">
                  <c:v>1.931</c:v>
                </c:pt>
                <c:pt idx="16">
                  <c:v>1.73</c:v>
                </c:pt>
                <c:pt idx="17">
                  <c:v>1.550999999999999</c:v>
                </c:pt>
                <c:pt idx="18">
                  <c:v>1.389</c:v>
                </c:pt>
                <c:pt idx="19">
                  <c:v>1.2449999999999992</c:v>
                </c:pt>
                <c:pt idx="20">
                  <c:v>1.1160000000000001</c:v>
                </c:pt>
                <c:pt idx="21">
                  <c:v>1</c:v>
                </c:pt>
              </c:numCache>
            </c:numRef>
          </c:xVal>
          <c:yVal>
            <c:numRef>
              <c:f>'Julio+48y49Nov'!$X$80:$X$101</c:f>
              <c:numCache>
                <c:formatCode>General</c:formatCode>
                <c:ptCount val="22"/>
                <c:pt idx="0">
                  <c:v>257.45</c:v>
                </c:pt>
                <c:pt idx="1">
                  <c:v>245.75</c:v>
                </c:pt>
                <c:pt idx="2">
                  <c:v>235.6</c:v>
                </c:pt>
                <c:pt idx="3">
                  <c:v>226.45000000000007</c:v>
                </c:pt>
                <c:pt idx="4">
                  <c:v>217.8</c:v>
                </c:pt>
                <c:pt idx="5">
                  <c:v>210.1</c:v>
                </c:pt>
                <c:pt idx="6">
                  <c:v>202.7</c:v>
                </c:pt>
                <c:pt idx="7">
                  <c:v>195.10000000000002</c:v>
                </c:pt>
                <c:pt idx="8">
                  <c:v>188.25</c:v>
                </c:pt>
                <c:pt idx="9">
                  <c:v>181.25</c:v>
                </c:pt>
                <c:pt idx="10">
                  <c:v>174.9</c:v>
                </c:pt>
                <c:pt idx="11">
                  <c:v>168.95000000000007</c:v>
                </c:pt>
                <c:pt idx="12">
                  <c:v>163.44999999999999</c:v>
                </c:pt>
                <c:pt idx="13">
                  <c:v>157.55000000000001</c:v>
                </c:pt>
                <c:pt idx="14">
                  <c:v>152.35000000000014</c:v>
                </c:pt>
                <c:pt idx="15">
                  <c:v>147.55000000000001</c:v>
                </c:pt>
                <c:pt idx="16">
                  <c:v>142.5</c:v>
                </c:pt>
                <c:pt idx="17">
                  <c:v>137.19999999999999</c:v>
                </c:pt>
                <c:pt idx="18">
                  <c:v>133.6</c:v>
                </c:pt>
                <c:pt idx="19">
                  <c:v>129.80000000000001</c:v>
                </c:pt>
                <c:pt idx="20">
                  <c:v>125.9</c:v>
                </c:pt>
                <c:pt idx="21">
                  <c:v>122.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E731-4EE4-B589-A9557F2911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296064"/>
        <c:axId val="42298368"/>
      </c:scatterChart>
      <c:valAx>
        <c:axId val="42296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/>
                  <a:t>Frecuency (Hz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298368"/>
        <c:crossesAt val="100"/>
        <c:crossBetween val="midCat"/>
      </c:valAx>
      <c:valAx>
        <c:axId val="42298368"/>
        <c:scaling>
          <c:logBase val="10"/>
          <c:orientation val="minMax"/>
          <c:max val="2000"/>
          <c:min val="100"/>
        </c:scaling>
        <c:delete val="0"/>
        <c:axPos val="l"/>
        <c:majorGridlines>
          <c:spPr>
            <a:ln w="6350" cap="flat" cmpd="sng" algn="ctr">
              <a:solidFill>
                <a:schemeClr val="tx1">
                  <a:tint val="75000"/>
                </a:schemeClr>
              </a:solidFill>
              <a:prstDash val="solid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/>
                  <a:t>Shear modulus (elastic and viscous component) (Pa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in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2960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66E85E-B2B6-4EDA-B02F-77477291D588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EC1721-6E4E-4028-8AA3-64C588E1A5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3060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7968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1041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5546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9896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379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567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4818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640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4762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2731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937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95762-BD90-46AC-A461-5D891BFFE4DC}" type="datetimeFigureOut">
              <a:rPr lang="es-ES" smtClean="0"/>
              <a:t>12/06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248EE-4AE2-4D04-B5CB-75D93CE45F9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5335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C02A3467-C393-46C2-AA1E-C7AE8CE7A03C}"/>
              </a:ext>
            </a:extLst>
          </p:cNvPr>
          <p:cNvSpPr/>
          <p:nvPr/>
        </p:nvSpPr>
        <p:spPr>
          <a:xfrm>
            <a:off x="849548" y="450602"/>
            <a:ext cx="10813915" cy="2788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95300" indent="-266700" algn="just">
              <a:lnSpc>
                <a:spcPts val="1300"/>
              </a:lnSpc>
              <a:spcAft>
                <a:spcPts val="0"/>
              </a:spcAft>
            </a:pPr>
            <a:r>
              <a:rPr lang="en-IE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s-ES" sz="16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3C302D21-35E4-464F-9A36-F5DED5764EF0}"/>
              </a:ext>
            </a:extLst>
          </p:cNvPr>
          <p:cNvSpPr/>
          <p:nvPr/>
        </p:nvSpPr>
        <p:spPr>
          <a:xfrm>
            <a:off x="1783403" y="1069929"/>
            <a:ext cx="7983167" cy="675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95300" indent="-266700" algn="just">
              <a:lnSpc>
                <a:spcPts val="1300"/>
              </a:lnSpc>
              <a:spcAft>
                <a:spcPts val="0"/>
              </a:spcAft>
            </a:pPr>
            <a:r>
              <a:rPr lang="en-IE" sz="1200" dirty="0">
                <a:latin typeface="Arial" panose="020B0604020202020204" pitchFamily="34" charset="0"/>
                <a:cs typeface="Arial" pitchFamily="34" charset="0"/>
              </a:rPr>
              <a:t> </a:t>
            </a:r>
            <a:endParaRPr lang="es-ES" sz="1200" dirty="0">
              <a:latin typeface="Arial" panose="020B0604020202020204" pitchFamily="34" charset="0"/>
              <a:cs typeface="Arial" pitchFamily="34" charset="0"/>
            </a:endParaRPr>
          </a:p>
          <a:p>
            <a:pPr algn="just">
              <a:lnSpc>
                <a:spcPts val="1700"/>
              </a:lnSpc>
              <a:spcAft>
                <a:spcPts val="0"/>
              </a:spcAft>
            </a:pPr>
            <a:r>
              <a:rPr lang="en-IE" sz="1200" b="1" dirty="0">
                <a:latin typeface="Arial" panose="020B0604020202020204" pitchFamily="34" charset="0"/>
                <a:cs typeface="Arial" pitchFamily="34" charset="0"/>
              </a:rPr>
              <a:t>Supplementary Table </a:t>
            </a:r>
            <a:r>
              <a:rPr lang="en-US" altLang="zh-CN" sz="1200" b="1" dirty="0">
                <a:latin typeface="Arial" panose="020B0604020202020204" pitchFamily="34" charset="0"/>
                <a:cs typeface="Arial" pitchFamily="34" charset="0"/>
              </a:rPr>
              <a:t>S</a:t>
            </a:r>
            <a:r>
              <a:rPr lang="en-IE" sz="1200" b="1" dirty="0">
                <a:latin typeface="Arial" panose="020B0604020202020204" pitchFamily="34" charset="0"/>
                <a:cs typeface="Arial" pitchFamily="34" charset="0"/>
              </a:rPr>
              <a:t>1. </a:t>
            </a:r>
            <a:r>
              <a:rPr lang="en-IE" sz="1200" dirty="0">
                <a:latin typeface="Arial" panose="020B0604020202020204" pitchFamily="34" charset="0"/>
                <a:cs typeface="Arial" pitchFamily="34" charset="0"/>
              </a:rPr>
              <a:t>Chromatographic and mass spectrum data of the phenolic compounds identified in W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M-H]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m / z): , MS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m /z): ,</a:t>
            </a:r>
            <a:r>
              <a:rPr lang="en-IE" sz="1200" dirty="0">
                <a:latin typeface="Arial" panose="020B0604020202020204" pitchFamily="34" charset="0"/>
                <a:cs typeface="Arial" pitchFamily="34" charset="0"/>
              </a:rPr>
              <a:t> R.T: Retention time.</a:t>
            </a:r>
            <a:endParaRPr lang="es-ES" sz="1200" dirty="0">
              <a:latin typeface="Arial" panose="020B0604020202020204" pitchFamily="34" charset="0"/>
              <a:cs typeface="Arial" pitchFamily="34" charset="0"/>
            </a:endParaRPr>
          </a:p>
        </p:txBody>
      </p:sp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D1985C24-C0C0-45F8-B8F7-519EEABB1A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6988835"/>
              </p:ext>
            </p:extLst>
          </p:nvPr>
        </p:nvGraphicFramePr>
        <p:xfrm>
          <a:off x="1996237" y="2038774"/>
          <a:ext cx="7557498" cy="13958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07964">
                  <a:extLst>
                    <a:ext uri="{9D8B030D-6E8A-4147-A177-3AD203B41FA5}">
                      <a16:colId xmlns:a16="http://schemas.microsoft.com/office/drawing/2014/main" val="192534173"/>
                    </a:ext>
                  </a:extLst>
                </a:gridCol>
                <a:gridCol w="592042">
                  <a:extLst>
                    <a:ext uri="{9D8B030D-6E8A-4147-A177-3AD203B41FA5}">
                      <a16:colId xmlns:a16="http://schemas.microsoft.com/office/drawing/2014/main" val="2502436564"/>
                    </a:ext>
                  </a:extLst>
                </a:gridCol>
                <a:gridCol w="482505">
                  <a:extLst>
                    <a:ext uri="{9D8B030D-6E8A-4147-A177-3AD203B41FA5}">
                      <a16:colId xmlns:a16="http://schemas.microsoft.com/office/drawing/2014/main" val="3189131282"/>
                    </a:ext>
                  </a:extLst>
                </a:gridCol>
                <a:gridCol w="577117">
                  <a:extLst>
                    <a:ext uri="{9D8B030D-6E8A-4147-A177-3AD203B41FA5}">
                      <a16:colId xmlns:a16="http://schemas.microsoft.com/office/drawing/2014/main" val="3056491586"/>
                    </a:ext>
                  </a:extLst>
                </a:gridCol>
                <a:gridCol w="3438449">
                  <a:extLst>
                    <a:ext uri="{9D8B030D-6E8A-4147-A177-3AD203B41FA5}">
                      <a16:colId xmlns:a16="http://schemas.microsoft.com/office/drawing/2014/main" val="3989794533"/>
                    </a:ext>
                  </a:extLst>
                </a:gridCol>
                <a:gridCol w="1659421">
                  <a:extLst>
                    <a:ext uri="{9D8B030D-6E8A-4147-A177-3AD203B41FA5}">
                      <a16:colId xmlns:a16="http://schemas.microsoft.com/office/drawing/2014/main" val="110247423"/>
                    </a:ext>
                  </a:extLst>
                </a:gridCol>
              </a:tblGrid>
              <a:tr h="388336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no.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M-H]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/z)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/z)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.T. (min)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ntative identification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olic class</a:t>
                      </a:r>
                      <a:endParaRPr lang="es-E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9463290"/>
                  </a:ext>
                </a:extLst>
              </a:tr>
              <a:tr h="184233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s-ES" sz="12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1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ffeic acid O-hexoside 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olic acid</a:t>
                      </a:r>
                      <a:endParaRPr lang="es-E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8824075"/>
                  </a:ext>
                </a:extLst>
              </a:tr>
              <a:tr h="184233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12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5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igenin-6/8-C-pentoside-8/6-C-hexoside (1)</a:t>
                      </a:r>
                      <a:endParaRPr lang="es-E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vone C-glycoside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653743"/>
                  </a:ext>
                </a:extLst>
              </a:tr>
              <a:tr h="184233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s-ES" sz="12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5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igenin-6/8-C-pentoside-8/6-C-hexoside (2)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vone C-glycoside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6755138"/>
                  </a:ext>
                </a:extLst>
              </a:tr>
              <a:tr h="184233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s-ES" sz="12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4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9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igenin-6-C-arabinoside-8-C-hexoside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vone C-glycoside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9969372"/>
                  </a:ext>
                </a:extLst>
              </a:tr>
              <a:tr h="184233"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s-ES" sz="12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5</a:t>
                      </a:r>
                      <a:endParaRPr lang="es-E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2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hydroferulic acid</a:t>
                      </a:r>
                      <a:endParaRPr lang="es-ES" sz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olic acid</a:t>
                      </a:r>
                      <a:endParaRPr lang="es-ES" sz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42021" marR="4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5483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0052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Rectángulo"/>
          <p:cNvSpPr/>
          <p:nvPr/>
        </p:nvSpPr>
        <p:spPr>
          <a:xfrm>
            <a:off x="1290084" y="277074"/>
            <a:ext cx="995509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S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1. </a:t>
            </a:r>
            <a:r>
              <a:rPr lang="en-GB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Pasting profiles of autoclaved wheat bran. Control, AUT100, AUT115 and  AUT130. The temperature profile is represented in the second axi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. 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97A77C4C-8082-4907-8768-18B6D772E7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317" y="834927"/>
            <a:ext cx="10949365" cy="518814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Rectángulo"/>
          <p:cNvSpPr/>
          <p:nvPr/>
        </p:nvSpPr>
        <p:spPr>
          <a:xfrm>
            <a:off x="1524000" y="476673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S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. 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Viscoelastic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moduli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elastic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G´, and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viscous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G´´)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evolution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i="1" dirty="0">
                <a:latin typeface="Arial" pitchFamily="34" charset="0"/>
                <a:cs typeface="Arial" pitchFamily="34" charset="0"/>
              </a:rPr>
              <a:t>vs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frecuency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of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autoclaved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wheat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bran.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Filled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line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represent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the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elastic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modulu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,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line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with gaps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represent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the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viscou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 </a:t>
            </a:r>
            <a:r>
              <a:rPr lang="es-ES" altLang="es-ES" sz="1200" dirty="0" err="1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modulus</a:t>
            </a:r>
            <a:r>
              <a:rPr lang="es-ES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. </a:t>
            </a:r>
            <a:r>
              <a:rPr lang="en-GB" altLang="es-ES" sz="1200" dirty="0">
                <a:latin typeface="Arial" pitchFamily="34" charset="0"/>
                <a:ea typeface="Calibri" panose="020F0502020204030204" pitchFamily="34" charset="0"/>
                <a:cs typeface="Arial" pitchFamily="34" charset="0"/>
              </a:rPr>
              <a:t>Control, AUT100, AUT115 and  AUT130. </a:t>
            </a:r>
            <a:endParaRPr lang="es-ES" altLang="es-ES" sz="1200" dirty="0">
              <a:latin typeface="Arial" pitchFamily="34" charset="0"/>
              <a:ea typeface="Calibri" panose="020F0502020204030204" pitchFamily="34" charset="0"/>
              <a:cs typeface="Arial" pitchFamily="34" charset="0"/>
            </a:endParaRPr>
          </a:p>
        </p:txBody>
      </p:sp>
      <p:graphicFrame>
        <p:nvGraphicFramePr>
          <p:cNvPr id="8" name="6 Gráfico"/>
          <p:cNvGraphicFramePr/>
          <p:nvPr>
            <p:extLst>
              <p:ext uri="{D42A27DB-BD31-4B8C-83A1-F6EECF244321}">
                <p14:modId xmlns:p14="http://schemas.microsoft.com/office/powerpoint/2010/main" val="3990112701"/>
              </p:ext>
            </p:extLst>
          </p:nvPr>
        </p:nvGraphicFramePr>
        <p:xfrm>
          <a:off x="1775520" y="1412777"/>
          <a:ext cx="8568952" cy="50249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31</TotalTime>
  <Words>208</Words>
  <Application>Microsoft Office PowerPoint</Application>
  <PresentationFormat>Widescreen</PresentationFormat>
  <Paragraphs>4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riana Villaverde Monar</dc:creator>
  <cp:lastModifiedBy>MDPI</cp:lastModifiedBy>
  <cp:revision>164</cp:revision>
  <dcterms:created xsi:type="dcterms:W3CDTF">2019-10-22T12:51:49Z</dcterms:created>
  <dcterms:modified xsi:type="dcterms:W3CDTF">2020-06-12T05:49:47Z</dcterms:modified>
</cp:coreProperties>
</file>